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3FA2D-573A-4F22-871C-051993DDCF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39CCD-A63A-4FFC-B853-3EC0B1FD9E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0576D-891A-44CE-9423-4DCFE05789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8DBEA-C724-45EE-A43C-D07FC532AD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17712-43D2-4321-AF59-80924AF51B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7FD50F-B6D1-4055-8F6C-1993CB9D12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0D893-EF5F-4543-86F8-C711268CCE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D99E6-FDCA-4788-9CB9-08848FC5D2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2D7F1-28D3-4DF6-A647-7548C652B7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9F6784-2A21-447F-991A-7772A90D48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465C7-6D29-45F1-950E-B699276D80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39F86-FE61-42F0-8C59-7DFEA5D5D9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25BFB0-1928-4F80-AF1D-B8402FF968C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1371600" y="1066680"/>
            <a:ext cx="6629400" cy="472464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5"/>
          <p:cNvSpPr/>
          <p:nvPr/>
        </p:nvSpPr>
        <p:spPr>
          <a:xfrm>
            <a:off x="1764360" y="533520"/>
            <a:ext cx="561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DR NC  VDR and GAPDH Real-time PCR produc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Rectangle 5"/>
          <p:cNvSpPr/>
          <p:nvPr/>
        </p:nvSpPr>
        <p:spPr>
          <a:xfrm>
            <a:off x="948960" y="1143000"/>
            <a:ext cx="6712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DR GAPDH and VDR cDNA Reverse Transcriptase PCR amplic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6" descr=""/>
          <p:cNvPicPr/>
          <p:nvPr/>
        </p:nvPicPr>
        <p:blipFill>
          <a:blip r:embed="rId1"/>
          <a:stretch/>
        </p:blipFill>
        <p:spPr>
          <a:xfrm>
            <a:off x="609480" y="1981080"/>
            <a:ext cx="7391520" cy="277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4" descr=""/>
          <p:cNvPicPr/>
          <p:nvPr/>
        </p:nvPicPr>
        <p:blipFill>
          <a:blip r:embed="rId1"/>
          <a:stretch/>
        </p:blipFill>
        <p:spPr>
          <a:xfrm>
            <a:off x="990720" y="1295280"/>
            <a:ext cx="7315200" cy="4724640"/>
          </a:xfrm>
          <a:prstGeom prst="rect">
            <a:avLst/>
          </a:prstGeom>
          <a:ln w="0">
            <a:noFill/>
          </a:ln>
        </p:spPr>
      </p:pic>
      <p:sp>
        <p:nvSpPr>
          <p:cNvPr id="46" name="Rectangle 5"/>
          <p:cNvSpPr/>
          <p:nvPr/>
        </p:nvSpPr>
        <p:spPr>
          <a:xfrm>
            <a:off x="2611080" y="838080"/>
            <a:ext cx="374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DR NC  VDR and GAPDH cD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4" descr=""/>
          <p:cNvPicPr/>
          <p:nvPr/>
        </p:nvPicPr>
        <p:blipFill>
          <a:blip r:embed="rId1"/>
          <a:stretch/>
        </p:blipFill>
        <p:spPr>
          <a:xfrm>
            <a:off x="990720" y="1676520"/>
            <a:ext cx="7315200" cy="4343400"/>
          </a:xfrm>
          <a:prstGeom prst="rect">
            <a:avLst/>
          </a:prstGeom>
          <a:ln w="0">
            <a:noFill/>
          </a:ln>
        </p:spPr>
      </p:pic>
      <p:sp>
        <p:nvSpPr>
          <p:cNvPr id="48" name="Rectangle 5"/>
          <p:cNvSpPr/>
          <p:nvPr/>
        </p:nvSpPr>
        <p:spPr>
          <a:xfrm>
            <a:off x="2535120" y="990720"/>
            <a:ext cx="374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DR NC  VDR and GAPDH cD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"/>
          <p:cNvPicPr/>
          <p:nvPr/>
        </p:nvPicPr>
        <p:blipFill>
          <a:blip r:embed="rId1"/>
          <a:srcRect l="0" t="0" r="0" b="49123"/>
          <a:stretch/>
        </p:blipFill>
        <p:spPr>
          <a:xfrm>
            <a:off x="685800" y="1371600"/>
            <a:ext cx="7315200" cy="342900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3"/>
          <p:cNvSpPr/>
          <p:nvPr/>
        </p:nvSpPr>
        <p:spPr>
          <a:xfrm>
            <a:off x="2469960" y="685800"/>
            <a:ext cx="374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DR NC  VDR and GAPDH cD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CRL</cp:lastModifiedBy>
  <dcterms:modified xsi:type="dcterms:W3CDTF">2024-05-13T05:33:12Z</dcterms:modified>
  <cp:revision>1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